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9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60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金澤 尚徳" userId="9a8c3a2d8aad46ef" providerId="LiveId" clId="{5C8C3D8E-268F-4393-ABD4-7D868EDF904C}"/>
    <pc:docChg chg="modSld">
      <pc:chgData name="金澤 尚徳" userId="9a8c3a2d8aad46ef" providerId="LiveId" clId="{5C8C3D8E-268F-4393-ABD4-7D868EDF904C}" dt="2022-02-16T11:02:12.605" v="25" actId="20577"/>
      <pc:docMkLst>
        <pc:docMk/>
      </pc:docMkLst>
      <pc:sldChg chg="modSp mod">
        <pc:chgData name="金澤 尚徳" userId="9a8c3a2d8aad46ef" providerId="LiveId" clId="{5C8C3D8E-268F-4393-ABD4-7D868EDF904C}" dt="2022-02-16T11:02:12.605" v="25" actId="20577"/>
        <pc:sldMkLst>
          <pc:docMk/>
          <pc:sldMk cId="841877300" sldId="256"/>
        </pc:sldMkLst>
        <pc:spChg chg="mod">
          <ac:chgData name="金澤 尚徳" userId="9a8c3a2d8aad46ef" providerId="LiveId" clId="{5C8C3D8E-268F-4393-ABD4-7D868EDF904C}" dt="2022-02-16T11:02:12.605" v="25" actId="20577"/>
          <ac:spMkLst>
            <pc:docMk/>
            <pc:sldMk cId="841877300" sldId="256"/>
            <ac:spMk id="32" creationId="{04FE10F5-35AB-49D5-BF7C-93083E75BD7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312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497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659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576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7206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608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788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61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571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887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2670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6E08B1-2EA1-4075-9D80-D70076B6579B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BE014B-9508-4C5D-974A-40DA330A7E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902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A8C9D9B0-DCFC-450B-BD13-9E2341612A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71" t="354" r="81574" b="-1"/>
          <a:stretch/>
        </p:blipFill>
        <p:spPr>
          <a:xfrm>
            <a:off x="1262239" y="835607"/>
            <a:ext cx="893057" cy="423853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5C3480C-4F07-4422-911A-16EAA06120A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" t="704" r="80623" b="351"/>
          <a:stretch/>
        </p:blipFill>
        <p:spPr>
          <a:xfrm>
            <a:off x="3658" y="835608"/>
            <a:ext cx="1222439" cy="4238532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BF3AACBA-CB3D-4B22-B476-AFB429A12A5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4" t="1218" r="79364" b="872"/>
          <a:stretch/>
        </p:blipFill>
        <p:spPr>
          <a:xfrm>
            <a:off x="2182356" y="835606"/>
            <a:ext cx="980593" cy="4238533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6338850-F63F-4EFA-84A9-6E0EEF361F1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2" t="466" r="79907" b="112"/>
          <a:stretch/>
        </p:blipFill>
        <p:spPr>
          <a:xfrm>
            <a:off x="3186611" y="835606"/>
            <a:ext cx="963565" cy="423853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418F33DF-AC45-4DEF-A0DB-B90FCE03B0B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2" r="79011" b="602"/>
          <a:stretch/>
        </p:blipFill>
        <p:spPr>
          <a:xfrm>
            <a:off x="4174549" y="835605"/>
            <a:ext cx="1324304" cy="4238533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FFF3EF6F-2273-4CFE-9757-820F3610445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3" t="1329" r="70479" b="981"/>
          <a:stretch/>
        </p:blipFill>
        <p:spPr>
          <a:xfrm>
            <a:off x="5521058" y="835605"/>
            <a:ext cx="1540588" cy="4238533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E32EE9E3-65ED-4EFE-BB6A-B75EDFD120B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5" t="900" r="79364" b="549"/>
          <a:stretch/>
        </p:blipFill>
        <p:spPr>
          <a:xfrm>
            <a:off x="7091811" y="835605"/>
            <a:ext cx="1026599" cy="4238533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C7A8C011-5596-43F3-B51B-1FC7F7DB985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9" t="715" r="80074" b="551"/>
          <a:stretch/>
        </p:blipFill>
        <p:spPr>
          <a:xfrm>
            <a:off x="8146652" y="831601"/>
            <a:ext cx="997348" cy="4238532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8C8E068-2709-4808-9358-2AC635A2B325}"/>
              </a:ext>
            </a:extLst>
          </p:cNvPr>
          <p:cNvSpPr txBox="1"/>
          <p:nvPr/>
        </p:nvSpPr>
        <p:spPr>
          <a:xfrm>
            <a:off x="345332" y="5282119"/>
            <a:ext cx="528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T1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D086F8A-9410-4961-BFCA-28CBAC433BC0}"/>
              </a:ext>
            </a:extLst>
          </p:cNvPr>
          <p:cNvSpPr txBox="1"/>
          <p:nvPr/>
        </p:nvSpPr>
        <p:spPr>
          <a:xfrm>
            <a:off x="1444303" y="5282119"/>
            <a:ext cx="528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T2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6DF9BEE-809C-4D9D-B562-88D206E33BC8}"/>
              </a:ext>
            </a:extLst>
          </p:cNvPr>
          <p:cNvSpPr txBox="1"/>
          <p:nvPr/>
        </p:nvSpPr>
        <p:spPr>
          <a:xfrm>
            <a:off x="2408188" y="5282119"/>
            <a:ext cx="528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T3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2608E49-93AB-4FE2-8D09-F05A1A7C6D01}"/>
              </a:ext>
            </a:extLst>
          </p:cNvPr>
          <p:cNvSpPr txBox="1"/>
          <p:nvPr/>
        </p:nvSpPr>
        <p:spPr>
          <a:xfrm>
            <a:off x="3403929" y="5282119"/>
            <a:ext cx="528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T4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4FF3338-54D0-4583-AEA0-3F0C0A763110}"/>
              </a:ext>
            </a:extLst>
          </p:cNvPr>
          <p:cNvSpPr txBox="1"/>
          <p:nvPr/>
        </p:nvSpPr>
        <p:spPr>
          <a:xfrm>
            <a:off x="4572237" y="5281800"/>
            <a:ext cx="528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T5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9502B76-E480-4912-ADD7-BDFC661A650F}"/>
              </a:ext>
            </a:extLst>
          </p:cNvPr>
          <p:cNvSpPr txBox="1"/>
          <p:nvPr/>
        </p:nvSpPr>
        <p:spPr>
          <a:xfrm>
            <a:off x="6026888" y="5281800"/>
            <a:ext cx="528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T6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8CC17C5-C41A-4E4C-BF88-8078C5130A4C}"/>
              </a:ext>
            </a:extLst>
          </p:cNvPr>
          <p:cNvSpPr txBox="1"/>
          <p:nvPr/>
        </p:nvSpPr>
        <p:spPr>
          <a:xfrm>
            <a:off x="7340646" y="5281800"/>
            <a:ext cx="528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T7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A14EC0C-2758-472F-93D6-492712166D26}"/>
              </a:ext>
            </a:extLst>
          </p:cNvPr>
          <p:cNvSpPr txBox="1"/>
          <p:nvPr/>
        </p:nvSpPr>
        <p:spPr>
          <a:xfrm>
            <a:off x="8380862" y="5281800"/>
            <a:ext cx="528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T8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4FE10F5-35AB-49D5-BF7C-93083E75BD74}"/>
              </a:ext>
            </a:extLst>
          </p:cNvPr>
          <p:cNvSpPr txBox="1"/>
          <p:nvPr/>
        </p:nvSpPr>
        <p:spPr>
          <a:xfrm>
            <a:off x="0" y="5844952"/>
            <a:ext cx="913913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Century" panose="02040604050505020304" pitchFamily="18" charset="0"/>
              </a:rPr>
              <a:t>The 12-lead ECG findings in each multiple focal </a:t>
            </a:r>
            <a:r>
              <a:rPr lang="en-US" altLang="ja-JP" sz="16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Century" panose="02040604050505020304" pitchFamily="18" charset="0"/>
              </a:rPr>
              <a:t>microreentrant</a:t>
            </a:r>
            <a:r>
              <a:rPr lang="en-US" altLang="ja-JP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Century" panose="02040604050505020304" pitchFamily="18" charset="0"/>
              </a:rPr>
              <a:t> atrial tachycardia episodes are shown with the reference of the intracardiac electrocardiogram of the coronary sinus catheter. A difference in the P wave morphology of V1 lead would help to distinguish several atrial tachycardias as unique tachycardias.</a:t>
            </a:r>
            <a:endParaRPr lang="ja-JP" altLang="ja-JP" sz="1100" kern="5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Century" panose="020406040505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AE5640A-07A3-45D7-84C1-BD7989909A7A}"/>
              </a:ext>
            </a:extLst>
          </p:cNvPr>
          <p:cNvSpPr txBox="1"/>
          <p:nvPr/>
        </p:nvSpPr>
        <p:spPr>
          <a:xfrm>
            <a:off x="87549" y="268449"/>
            <a:ext cx="8968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Century" panose="02040604050505020304" pitchFamily="18" charset="0"/>
              </a:rPr>
              <a:t>Supplemental Figure</a:t>
            </a:r>
            <a:endParaRPr lang="ja-JP" altLang="ja-JP" sz="1200" b="1" kern="5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1877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5</TotalTime>
  <Words>58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澤 尚徳</dc:creator>
  <cp:lastModifiedBy>金澤 尚徳</cp:lastModifiedBy>
  <cp:revision>1</cp:revision>
  <dcterms:created xsi:type="dcterms:W3CDTF">2022-01-12T14:09:30Z</dcterms:created>
  <dcterms:modified xsi:type="dcterms:W3CDTF">2022-02-16T11:02:57Z</dcterms:modified>
</cp:coreProperties>
</file>